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Destaqu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Estilo Mé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35"/>
    <p:restoredTop sz="94674"/>
  </p:normalViewPr>
  <p:slideViewPr>
    <p:cSldViewPr snapToGrid="0">
      <p:cViewPr varScale="1">
        <p:scale>
          <a:sx n="119" d="100"/>
          <a:sy n="119" d="100"/>
        </p:scale>
        <p:origin x="64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CFDE5A-CD4C-084E-8530-1FD0D1A54066}" type="datetimeFigureOut">
              <a:rPr lang="en-GB" smtClean="0"/>
              <a:t>16/01/2025</a:t>
            </a:fld>
            <a:endParaRPr lang="en-GB"/>
          </a:p>
        </p:txBody>
      </p:sp>
      <p:sp>
        <p:nvSpPr>
          <p:cNvPr id="4" name="Marcador de Posição da Imagem do Diapositivo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Marcador de Posição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FA8C97-AF27-DC45-83FF-529DB1872A3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36951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FA8C97-AF27-DC45-83FF-529DB1872A3C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1616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7CFC8E1-0B15-30DB-80DE-292BCFB208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96CE3FC-0E19-A9B7-969E-01BB29E375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D4B7250A-4A13-20EE-0096-DAC55CF4D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464A-97D0-EB41-8204-1E8354B48CED}" type="datetimeFigureOut">
              <a:rPr lang="en-GB" smtClean="0"/>
              <a:t>16/01/2025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95E22F31-5AA7-9DA0-39A4-DA26F11BB6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01810D63-495B-E03E-F120-5FF5A87D56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26375-46A6-8D42-8D2C-1F1FD2FCFE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9065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210037E-312F-ABCB-68E7-165E655643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1E206C6E-5630-CC3A-E996-DAEEB5B28E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58E5F609-5A3B-D4F8-577A-F0C89456F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464A-97D0-EB41-8204-1E8354B48CED}" type="datetimeFigureOut">
              <a:rPr lang="en-GB" smtClean="0"/>
              <a:t>16/01/2025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D05FF005-CA75-A76B-0901-EC22EBE7D5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3FD0C1DD-CA5B-5D0E-1E28-1E705EB4A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26375-46A6-8D42-8D2C-1F1FD2FCFE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9385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04AE630-AF74-15F7-97BA-2BC7786003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29A67CC4-0025-5470-4746-D2CA948110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46432EA9-AD48-3286-B84F-E952BC8C96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464A-97D0-EB41-8204-1E8354B48CED}" type="datetimeFigureOut">
              <a:rPr lang="en-GB" smtClean="0"/>
              <a:t>16/01/2025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E7300D15-C17B-6178-F7C7-03F59BF54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D762D97F-5939-453F-0094-704815A63C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26375-46A6-8D42-8D2C-1F1FD2FCFE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4073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8201ED7-C04E-4223-8ED2-7F4A84C39D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EBAC8236-BDAD-90EB-7935-D97070FCA2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0B7FE1FC-7800-7D97-17E6-52AC1B6576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464A-97D0-EB41-8204-1E8354B48CED}" type="datetimeFigureOut">
              <a:rPr lang="en-GB" smtClean="0"/>
              <a:t>16/01/2025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0B45862A-D8B1-EE43-F9C5-A76164BA68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5D7ACF95-A369-A491-2D97-8C5C901AC8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26375-46A6-8D42-8D2C-1F1FD2FCFE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5324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9B1538E-42A9-2FBB-4FFC-9EA4F89CF9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B17D6390-A2F5-6CCB-5ECE-92074786F1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C189CBF6-9129-8B50-A916-47441E06D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464A-97D0-EB41-8204-1E8354B48CED}" type="datetimeFigureOut">
              <a:rPr lang="en-GB" smtClean="0"/>
              <a:t>16/01/2025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73372DE5-E09D-DF78-97BA-847A23B7FF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2D9099E6-D1D8-B738-D89B-71910DA6B5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26375-46A6-8D42-8D2C-1F1FD2FCFE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0458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A3E0D1-E204-BBD5-3F3F-73EB41BBD9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A101E5B7-AC12-E244-3E5C-04E1A9DD17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A15C0327-3CAB-2E7A-B96D-6B630003B2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F1CDAD49-E90C-CDDA-CCAE-1FDFE67151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464A-97D0-EB41-8204-1E8354B48CED}" type="datetimeFigureOut">
              <a:rPr lang="en-GB" smtClean="0"/>
              <a:t>16/01/2025</a:t>
            </a:fld>
            <a:endParaRPr lang="en-GB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D7D86161-7BB5-B5EC-76EB-826C2BBA05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8FFE1612-F1DF-AF37-BAF3-3FBB11DD1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26375-46A6-8D42-8D2C-1F1FD2FCFE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5446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8B1E1A9-C0FF-7D06-9EB1-B073CD7644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FC4BC0DC-01FC-5F63-62FD-59A661DB07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ACC36CE1-AC29-A16F-A2BF-BB6156AB8D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5" name="Marcador de Posição do Texto 4">
            <a:extLst>
              <a:ext uri="{FF2B5EF4-FFF2-40B4-BE49-F238E27FC236}">
                <a16:creationId xmlns:a16="http://schemas.microsoft.com/office/drawing/2014/main" id="{CF59ECD2-2865-999E-28EE-F9A48C1088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:a16="http://schemas.microsoft.com/office/drawing/2014/main" id="{D3AD179E-4929-E3FD-6033-DB23C25923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7" name="Marcador de Posição da Data 6">
            <a:extLst>
              <a:ext uri="{FF2B5EF4-FFF2-40B4-BE49-F238E27FC236}">
                <a16:creationId xmlns:a16="http://schemas.microsoft.com/office/drawing/2014/main" id="{374D89B7-7C68-B29B-6C2E-5AF0E2903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464A-97D0-EB41-8204-1E8354B48CED}" type="datetimeFigureOut">
              <a:rPr lang="en-GB" smtClean="0"/>
              <a:t>16/01/2025</a:t>
            </a:fld>
            <a:endParaRPr lang="en-GB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:a16="http://schemas.microsoft.com/office/drawing/2014/main" id="{FDBBCAB9-4A77-3DE9-D7E8-C5215647A3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:a16="http://schemas.microsoft.com/office/drawing/2014/main" id="{B8996837-F730-040C-303D-BA92B1D662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26375-46A6-8D42-8D2C-1F1FD2FCFE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0235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2648747-FA4B-2982-E694-9ABC414C64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a Data 2">
            <a:extLst>
              <a:ext uri="{FF2B5EF4-FFF2-40B4-BE49-F238E27FC236}">
                <a16:creationId xmlns:a16="http://schemas.microsoft.com/office/drawing/2014/main" id="{AAB9F913-65CB-375D-03A2-07D8009F37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464A-97D0-EB41-8204-1E8354B48CED}" type="datetimeFigureOut">
              <a:rPr lang="en-GB" smtClean="0"/>
              <a:t>16/01/2025</a:t>
            </a:fld>
            <a:endParaRPr lang="en-GB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:a16="http://schemas.microsoft.com/office/drawing/2014/main" id="{5FE85917-9527-16A9-66FF-30EFD21B6E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:a16="http://schemas.microsoft.com/office/drawing/2014/main" id="{0187B6EF-7558-2640-CCEC-6ED77CDF5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26375-46A6-8D42-8D2C-1F1FD2FCFE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71401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:a16="http://schemas.microsoft.com/office/drawing/2014/main" id="{A982425D-8F60-6C45-6D30-92F48768C7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464A-97D0-EB41-8204-1E8354B48CED}" type="datetimeFigureOut">
              <a:rPr lang="en-GB" smtClean="0"/>
              <a:t>16/01/2025</a:t>
            </a:fld>
            <a:endParaRPr lang="en-GB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:a16="http://schemas.microsoft.com/office/drawing/2014/main" id="{0A6B6E61-272A-D8E5-9738-F3A2B3E27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7FBFFDAC-AAE8-8E56-33DA-1B6B73875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26375-46A6-8D42-8D2C-1F1FD2FCFE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6454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993373E-926C-46F5-214F-AD2125F181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45B8BB90-D3E6-BA3E-2D27-B9EF29A5E0E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76579831-C1B2-F921-F3E3-DB84F8462C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2A4958DE-58DB-6F42-B8D5-D395F5CF9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464A-97D0-EB41-8204-1E8354B48CED}" type="datetimeFigureOut">
              <a:rPr lang="en-GB" smtClean="0"/>
              <a:t>16/01/2025</a:t>
            </a:fld>
            <a:endParaRPr lang="en-GB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A7D26D46-4B29-6EBB-C32B-8CD9564F54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AB335BEF-0517-82BD-A9D3-F3F0A1F3E3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26375-46A6-8D42-8D2C-1F1FD2FCFE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4635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9C92694-DEA8-B98E-E0FC-26F8637396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:a16="http://schemas.microsoft.com/office/drawing/2014/main" id="{E587F55D-8FB6-1C3E-B048-703B4FEEEF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D81051B6-077F-F28B-4E40-A85F98DF85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374EAEDC-7D20-65EF-5F3D-DA6EF81D31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1464A-97D0-EB41-8204-1E8354B48CED}" type="datetimeFigureOut">
              <a:rPr lang="en-GB" smtClean="0"/>
              <a:t>16/01/2025</a:t>
            </a:fld>
            <a:endParaRPr lang="en-GB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01D89005-0757-42D7-E35D-7DCBAA8C0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BA8B8ABB-5872-BC8C-9900-5C6BC254D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226375-46A6-8D42-8D2C-1F1FD2FCFE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6222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:a16="http://schemas.microsoft.com/office/drawing/2014/main" id="{0685DE4E-215D-C889-C022-EBAFC0A62E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1344E2B4-AE00-79C0-1736-CB53FD411E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4D1DC214-D152-ED4E-1333-E846097257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11464A-97D0-EB41-8204-1E8354B48CED}" type="datetimeFigureOut">
              <a:rPr lang="en-GB" smtClean="0"/>
              <a:t>16/01/2025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A0A608AA-DD04-5312-23D4-40A919DD806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121B7792-6C31-1129-6146-063009F35E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226375-46A6-8D42-8D2C-1F1FD2FCFE0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4869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ixaDeTexto 7">
            <a:extLst>
              <a:ext uri="{FF2B5EF4-FFF2-40B4-BE49-F238E27FC236}">
                <a16:creationId xmlns:a16="http://schemas.microsoft.com/office/drawing/2014/main" id="{6DD482C4-9880-5CB5-44BC-315E2E8FAB27}"/>
              </a:ext>
            </a:extLst>
          </p:cNvPr>
          <p:cNvSpPr txBox="1"/>
          <p:nvPr/>
        </p:nvSpPr>
        <p:spPr>
          <a:xfrm>
            <a:off x="437411" y="1135024"/>
            <a:ext cx="1138615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Palatino" pitchFamily="2" charset="77"/>
                <a:ea typeface="Palatino" pitchFamily="2" charset="77"/>
              </a:rPr>
              <a:t>Supplementary file Table S2. </a:t>
            </a:r>
            <a:r>
              <a:rPr lang="en-GB" sz="1200" i="1" dirty="0">
                <a:latin typeface="Palatino" pitchFamily="2" charset="77"/>
                <a:ea typeface="Palatino" pitchFamily="2" charset="77"/>
              </a:rPr>
              <a:t>B. </a:t>
            </a:r>
            <a:r>
              <a:rPr lang="en-GB" sz="1200" i="1" dirty="0" err="1">
                <a:latin typeface="Palatino" pitchFamily="2" charset="77"/>
                <a:ea typeface="Palatino" pitchFamily="2" charset="77"/>
              </a:rPr>
              <a:t>ceti</a:t>
            </a:r>
            <a:r>
              <a:rPr lang="en-GB" sz="1200" i="1" dirty="0">
                <a:latin typeface="Palatino" pitchFamily="2" charset="77"/>
                <a:ea typeface="Palatino" pitchFamily="2" charset="77"/>
              </a:rPr>
              <a:t> </a:t>
            </a:r>
            <a:r>
              <a:rPr lang="en-GB" sz="1200" dirty="0">
                <a:latin typeface="Palatino" pitchFamily="2" charset="77"/>
                <a:ea typeface="Palatino" pitchFamily="2" charset="77"/>
              </a:rPr>
              <a:t>strains assembled contigs available at NCBI used for ParSNP analysis.</a:t>
            </a:r>
            <a:endParaRPr lang="en-GB" sz="1200" b="1" dirty="0">
              <a:latin typeface="Palatino" pitchFamily="2" charset="77"/>
              <a:ea typeface="Palatino" pitchFamily="2" charset="77"/>
            </a:endParaRPr>
          </a:p>
        </p:txBody>
      </p:sp>
      <p:graphicFrame>
        <p:nvGraphicFramePr>
          <p:cNvPr id="2" name="Tabela 1">
            <a:extLst>
              <a:ext uri="{FF2B5EF4-FFF2-40B4-BE49-F238E27FC236}">
                <a16:creationId xmlns:a16="http://schemas.microsoft.com/office/drawing/2014/main" id="{96725F7E-3DBC-DCAA-EF9C-4B82CF49306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1198388"/>
              </p:ext>
            </p:extLst>
          </p:nvPr>
        </p:nvGraphicFramePr>
        <p:xfrm>
          <a:off x="571746" y="1487198"/>
          <a:ext cx="11117491" cy="4235778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073A0DAA-6AF3-43AB-8588-CEC1D06C72B9}</a:tableStyleId>
              </a:tblPr>
              <a:tblGrid>
                <a:gridCol w="1257054">
                  <a:extLst>
                    <a:ext uri="{9D8B030D-6E8A-4147-A177-3AD203B41FA5}">
                      <a16:colId xmlns:a16="http://schemas.microsoft.com/office/drawing/2014/main" val="2640724402"/>
                    </a:ext>
                  </a:extLst>
                </a:gridCol>
                <a:gridCol w="1838848">
                  <a:extLst>
                    <a:ext uri="{9D8B030D-6E8A-4147-A177-3AD203B41FA5}">
                      <a16:colId xmlns:a16="http://schemas.microsoft.com/office/drawing/2014/main" val="4064638926"/>
                    </a:ext>
                  </a:extLst>
                </a:gridCol>
                <a:gridCol w="2799140">
                  <a:extLst>
                    <a:ext uri="{9D8B030D-6E8A-4147-A177-3AD203B41FA5}">
                      <a16:colId xmlns:a16="http://schemas.microsoft.com/office/drawing/2014/main" val="4267502250"/>
                    </a:ext>
                  </a:extLst>
                </a:gridCol>
                <a:gridCol w="5222449">
                  <a:extLst>
                    <a:ext uri="{9D8B030D-6E8A-4147-A177-3AD203B41FA5}">
                      <a16:colId xmlns:a16="http://schemas.microsoft.com/office/drawing/2014/main" val="2186344209"/>
                    </a:ext>
                  </a:extLst>
                </a:gridCol>
              </a:tblGrid>
              <a:tr h="553884"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r>
                        <a:rPr lang="en-US" sz="1200" i="1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B. </a:t>
                      </a:r>
                      <a:r>
                        <a:rPr lang="en-US" sz="1200" i="1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ceti</a:t>
                      </a:r>
                      <a:r>
                        <a:rPr lang="en-US" sz="1200" i="1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strains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NCBI accession number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r>
                        <a:rPr lang="pt-PT" sz="1200" b="1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Host</a:t>
                      </a:r>
                      <a:endParaRPr lang="pt-PT" sz="1200" b="1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r>
                        <a:rPr lang="pt-PT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Country and date of </a:t>
                      </a:r>
                      <a:r>
                        <a:rPr lang="pt-PT" sz="120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isolation</a:t>
                      </a:r>
                      <a:r>
                        <a:rPr lang="pt-PT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(</a:t>
                      </a:r>
                      <a:r>
                        <a:rPr lang="pt-PT" sz="120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Reference</a:t>
                      </a:r>
                      <a:r>
                        <a:rPr lang="pt-PT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)</a:t>
                      </a: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1793270"/>
                  </a:ext>
                </a:extLst>
              </a:tr>
              <a:tr h="377386">
                <a:tc>
                  <a:txBody>
                    <a:bodyPr/>
                    <a:lstStyle/>
                    <a:p>
                      <a:pPr marL="73660" algn="l">
                        <a:lnSpc>
                          <a:spcPts val="1020"/>
                        </a:lnSpc>
                        <a:spcBef>
                          <a:spcPts val="235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TE10759-12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235"/>
                        </a:spcBef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GCA_000590795.1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r>
                        <a:rPr lang="pt-PT" sz="1200" b="0" i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Striped</a:t>
                      </a:r>
                      <a:r>
                        <a:rPr lang="pt-PT" sz="1200" b="0" i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200" b="0" i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dolphin</a:t>
                      </a:r>
                      <a:r>
                        <a:rPr lang="pt-PT" sz="1200" b="0" i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, </a:t>
                      </a:r>
                      <a:r>
                        <a:rPr lang="pt-PT" sz="1200" b="0" i="1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Stenella</a:t>
                      </a:r>
                      <a:r>
                        <a:rPr lang="pt-PT" sz="1200" b="0" i="1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200" b="0" i="1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coeruleoalba</a:t>
                      </a:r>
                      <a:endParaRPr lang="pt-PT" sz="1200" b="0" i="1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235"/>
                        </a:spcBef>
                      </a:pPr>
                      <a:r>
                        <a:rPr lang="pt-PT" sz="1100" b="0" i="0" kern="1200" dirty="0" err="1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Adriatic</a:t>
                      </a:r>
                      <a:r>
                        <a:rPr lang="pt-PT" sz="11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100" b="0" i="0" kern="1200" dirty="0" err="1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Sea</a:t>
                      </a:r>
                      <a:r>
                        <a:rPr lang="pt-PT" sz="11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, </a:t>
                      </a:r>
                      <a:r>
                        <a:rPr lang="pt-PT" sz="1100" b="0" i="0" kern="1200" dirty="0" err="1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Italy</a:t>
                      </a:r>
                      <a:r>
                        <a:rPr lang="pt-PT" sz="11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, 2012 </a:t>
                      </a:r>
                      <a:r>
                        <a:rPr lang="pt-PT" sz="10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(Ancora </a:t>
                      </a:r>
                      <a:r>
                        <a:rPr lang="pt-PT" sz="1000" b="0" i="1" kern="1200" dirty="0" err="1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et</a:t>
                      </a:r>
                      <a:r>
                        <a:rPr lang="pt-PT" sz="1000" b="0" i="1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al</a:t>
                      </a:r>
                      <a:r>
                        <a:rPr lang="pt-PT" sz="10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. 2014.  </a:t>
                      </a:r>
                      <a:r>
                        <a:rPr lang="pt-PT" sz="1000" b="0" i="0" kern="1200" dirty="0" err="1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https</a:t>
                      </a:r>
                      <a:r>
                        <a:rPr lang="pt-PT" sz="10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://</a:t>
                      </a:r>
                      <a:r>
                        <a:rPr lang="pt-PT" sz="1000" b="0" i="0" kern="1200" dirty="0" err="1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doi.org</a:t>
                      </a:r>
                      <a:r>
                        <a:rPr lang="pt-PT" sz="10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/10.1128/genomea.00068-14)</a:t>
                      </a:r>
                      <a:endParaRPr lang="pt-PT" sz="1000" b="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2258224"/>
                  </a:ext>
                </a:extLst>
              </a:tr>
              <a:tr h="362290">
                <a:tc>
                  <a:txBody>
                    <a:bodyPr/>
                    <a:lstStyle/>
                    <a:p>
                      <a:pPr marL="73660" algn="l">
                        <a:lnSpc>
                          <a:spcPts val="1020"/>
                        </a:lnSpc>
                        <a:spcBef>
                          <a:spcPts val="175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TE28753-12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GCA_000590815.1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r>
                        <a:rPr lang="pt-PT" sz="1200" b="0" i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Striped</a:t>
                      </a:r>
                      <a:r>
                        <a:rPr lang="pt-PT" sz="1200" b="0" i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200" b="0" i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dolphin</a:t>
                      </a:r>
                      <a:r>
                        <a:rPr lang="pt-PT" sz="1200" b="0" i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, </a:t>
                      </a:r>
                      <a:r>
                        <a:rPr lang="pt-PT" sz="1200" b="0" i="1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Stenella</a:t>
                      </a:r>
                      <a:r>
                        <a:rPr lang="pt-PT" sz="1200" b="0" i="1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200" b="0" i="1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coeruleoalba</a:t>
                      </a:r>
                      <a:endParaRPr lang="pt-PT" sz="1200" b="0" i="1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235"/>
                        </a:spcBef>
                      </a:pPr>
                      <a:r>
                        <a:rPr lang="pt-PT" sz="1100" b="0" i="0" kern="1200" dirty="0" err="1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Adriatic</a:t>
                      </a:r>
                      <a:r>
                        <a:rPr lang="pt-PT" sz="11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100" b="0" i="0" kern="1200" dirty="0" err="1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Sea</a:t>
                      </a:r>
                      <a:r>
                        <a:rPr lang="pt-PT" sz="11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, </a:t>
                      </a:r>
                      <a:r>
                        <a:rPr lang="pt-PT" sz="1100" b="0" i="0" kern="1200" dirty="0" err="1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Italy</a:t>
                      </a:r>
                      <a:r>
                        <a:rPr lang="pt-PT" sz="11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, 2012 </a:t>
                      </a:r>
                      <a:r>
                        <a:rPr lang="pt-PT" sz="10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(Ancora </a:t>
                      </a:r>
                      <a:r>
                        <a:rPr lang="pt-PT" sz="1000" b="0" i="1" kern="1200" dirty="0" err="1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et</a:t>
                      </a:r>
                      <a:r>
                        <a:rPr lang="pt-PT" sz="1000" b="0" i="1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al</a:t>
                      </a:r>
                      <a:r>
                        <a:rPr lang="pt-PT" sz="10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. 2014.  </a:t>
                      </a:r>
                      <a:r>
                        <a:rPr lang="pt-PT" sz="1000" b="0" i="0" kern="1200" dirty="0" err="1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https</a:t>
                      </a:r>
                      <a:r>
                        <a:rPr lang="pt-PT" sz="10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://</a:t>
                      </a:r>
                      <a:r>
                        <a:rPr lang="pt-PT" sz="1000" b="0" i="0" kern="1200" dirty="0" err="1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doi.org</a:t>
                      </a:r>
                      <a:r>
                        <a:rPr lang="pt-PT" sz="10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/10.1128/genomea.00068-14)</a:t>
                      </a:r>
                      <a:endParaRPr lang="pt-PT" sz="1000" b="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0803967"/>
                  </a:ext>
                </a:extLst>
              </a:tr>
              <a:tr h="378644">
                <a:tc>
                  <a:txBody>
                    <a:bodyPr/>
                    <a:lstStyle/>
                    <a:p>
                      <a:pPr marL="73660" algn="l">
                        <a:lnSpc>
                          <a:spcPts val="1020"/>
                        </a:lnSpc>
                        <a:spcBef>
                          <a:spcPts val="24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B1/ 94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240"/>
                        </a:spcBef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GCA_000158775.1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r>
                        <a:rPr lang="pt-PT" sz="1200" b="0" i="0" kern="1200" dirty="0" err="1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Striped</a:t>
                      </a:r>
                      <a:r>
                        <a:rPr lang="pt-PT" sz="1200" b="0" i="0" kern="1200" dirty="0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200" b="0" i="0" kern="1200" dirty="0" err="1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dolphin</a:t>
                      </a:r>
                      <a:r>
                        <a:rPr lang="pt-PT" sz="1200" b="0" i="0" kern="1200" dirty="0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200" b="0" i="1" kern="1200" dirty="0" err="1">
                          <a:solidFill>
                            <a:schemeClr val="dk1"/>
                          </a:solidFill>
                          <a:effectLst/>
                          <a:highlight>
                            <a:srgbClr val="FFFF00"/>
                          </a:highlight>
                          <a:latin typeface="Palatino"/>
                          <a:ea typeface="+mn-ea"/>
                          <a:cs typeface="+mn-cs"/>
                        </a:rPr>
                        <a:t>Stenella</a:t>
                      </a:r>
                      <a:r>
                        <a:rPr lang="pt-PT" sz="1200" b="0" i="1" kern="1200" dirty="0">
                          <a:solidFill>
                            <a:schemeClr val="dk1"/>
                          </a:solidFill>
                          <a:effectLst/>
                          <a:highlight>
                            <a:srgbClr val="FFFF00"/>
                          </a:highlight>
                          <a:latin typeface="Palatino"/>
                          <a:ea typeface="+mn-ea"/>
                          <a:cs typeface="+mn-cs"/>
                        </a:rPr>
                        <a:t> </a:t>
                      </a:r>
                      <a:r>
                        <a:rPr lang="pt-PT" sz="1200" b="0" i="1" kern="1200" dirty="0" err="1">
                          <a:solidFill>
                            <a:schemeClr val="dk1"/>
                          </a:solidFill>
                          <a:effectLst/>
                          <a:highlight>
                            <a:srgbClr val="FFFF00"/>
                          </a:highlight>
                          <a:latin typeface="Palatino"/>
                          <a:ea typeface="+mn-ea"/>
                          <a:cs typeface="+mn-cs"/>
                        </a:rPr>
                        <a:t>coeruleoalba</a:t>
                      </a:r>
                      <a:endParaRPr lang="pt-PT" sz="1000" b="0" i="1" kern="1200" dirty="0">
                        <a:solidFill>
                          <a:schemeClr val="tx1"/>
                        </a:solidFill>
                        <a:highlight>
                          <a:srgbClr val="FFFF00"/>
                        </a:highlight>
                        <a:latin typeface="Palatino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240"/>
                        </a:spcBef>
                      </a:pPr>
                      <a:r>
                        <a:rPr lang="pt-PT" sz="1100" b="0" kern="1200" dirty="0" err="1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Italy</a:t>
                      </a:r>
                      <a:r>
                        <a:rPr lang="pt-PT" sz="1100" b="0" kern="1200" dirty="0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(</a:t>
                      </a:r>
                      <a:r>
                        <a:rPr lang="pt-PT" sz="1000" b="0" i="0" kern="1200" dirty="0" err="1">
                          <a:solidFill>
                            <a:schemeClr val="tx1"/>
                          </a:solidFill>
                          <a:effectLst/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Foster</a:t>
                      </a:r>
                      <a:r>
                        <a:rPr lang="pt-PT" sz="1000" b="0" i="0" kern="1200" dirty="0">
                          <a:solidFill>
                            <a:schemeClr val="tx1"/>
                          </a:solidFill>
                          <a:effectLst/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000" b="0" i="1" kern="1200" dirty="0" err="1">
                          <a:solidFill>
                            <a:schemeClr val="tx1"/>
                          </a:solidFill>
                          <a:effectLst/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et</a:t>
                      </a:r>
                      <a:r>
                        <a:rPr lang="pt-PT" sz="1000" b="0" i="1" kern="1200" dirty="0">
                          <a:solidFill>
                            <a:schemeClr val="tx1"/>
                          </a:solidFill>
                          <a:effectLst/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al</a:t>
                      </a:r>
                      <a:r>
                        <a:rPr lang="pt-PT" sz="1000" b="0" i="0" kern="1200" dirty="0">
                          <a:solidFill>
                            <a:schemeClr val="tx1"/>
                          </a:solidFill>
                          <a:effectLst/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. 2007. doi: 10.1099/ijs.0.65269-0. PMID: 17978241)</a:t>
                      </a: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6322768"/>
                  </a:ext>
                </a:extLst>
              </a:tr>
              <a:tr h="362290">
                <a:tc>
                  <a:txBody>
                    <a:bodyPr/>
                    <a:lstStyle/>
                    <a:p>
                      <a:pPr marL="73660" algn="l">
                        <a:lnSpc>
                          <a:spcPts val="1020"/>
                        </a:lnSpc>
                        <a:spcBef>
                          <a:spcPts val="175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B1/ 94 V2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GCA_000662035.2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20"/>
                        </a:lnSpc>
                        <a:spcBef>
                          <a:spcPts val="175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PT" sz="1200" b="0" kern="1200" dirty="0" err="1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Harbor</a:t>
                      </a:r>
                      <a:r>
                        <a:rPr lang="pt-PT" sz="1200" b="0" kern="1200" dirty="0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200" b="0" kern="1200" dirty="0" err="1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porpoise</a:t>
                      </a:r>
                      <a:r>
                        <a:rPr lang="pt-PT" sz="1200" b="0" kern="1200" dirty="0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, </a:t>
                      </a:r>
                      <a:r>
                        <a:rPr lang="pt-PT" sz="1200" b="0" i="1" kern="1200" dirty="0" err="1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Phocoena</a:t>
                      </a:r>
                      <a:r>
                        <a:rPr lang="pt-PT" sz="1200" b="0" i="1" kern="1200" dirty="0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200" b="0" i="1" kern="1200" dirty="0" err="1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phocoena</a:t>
                      </a:r>
                      <a:endParaRPr lang="pt-PT" sz="1200" b="0" i="1" kern="1200" dirty="0">
                        <a:solidFill>
                          <a:schemeClr val="tx1"/>
                        </a:solidFill>
                        <a:highlight>
                          <a:srgbClr val="FFFF00"/>
                        </a:highlight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20"/>
                        </a:lnSpc>
                        <a:spcBef>
                          <a:spcPts val="175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PT" sz="1000" b="0" kern="1200" dirty="0" err="1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Italy</a:t>
                      </a:r>
                      <a:r>
                        <a:rPr lang="pt-PT" sz="1000" b="0" kern="1200" dirty="0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(</a:t>
                      </a:r>
                      <a:r>
                        <a:rPr lang="pt-PT" sz="1000" b="0" i="0" kern="1200" dirty="0" err="1">
                          <a:solidFill>
                            <a:schemeClr val="tx1"/>
                          </a:solidFill>
                          <a:effectLst/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Foster</a:t>
                      </a:r>
                      <a:r>
                        <a:rPr lang="pt-PT" sz="1000" b="0" i="0" kern="1200" dirty="0">
                          <a:solidFill>
                            <a:schemeClr val="tx1"/>
                          </a:solidFill>
                          <a:effectLst/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000" b="0" i="1" kern="1200" dirty="0" err="1">
                          <a:solidFill>
                            <a:schemeClr val="tx1"/>
                          </a:solidFill>
                          <a:effectLst/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et</a:t>
                      </a:r>
                      <a:r>
                        <a:rPr lang="pt-PT" sz="1000" b="0" i="1" kern="1200" dirty="0">
                          <a:solidFill>
                            <a:schemeClr val="tx1"/>
                          </a:solidFill>
                          <a:effectLst/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al</a:t>
                      </a:r>
                      <a:r>
                        <a:rPr lang="pt-PT" sz="1000" b="0" i="0" kern="1200" dirty="0">
                          <a:solidFill>
                            <a:schemeClr val="tx1"/>
                          </a:solidFill>
                          <a:effectLst/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. 2007. doi: 10.1099/ijs.0.65269-0. PMID: 17978241)</a:t>
                      </a:r>
                    </a:p>
                    <a:p>
                      <a:pPr algn="l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endParaRPr lang="pt-PT" sz="1100" b="0" kern="1200" dirty="0">
                        <a:solidFill>
                          <a:schemeClr val="tx1"/>
                        </a:solidFill>
                        <a:highlight>
                          <a:srgbClr val="FFFF00"/>
                        </a:highlight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9722974"/>
                  </a:ext>
                </a:extLst>
              </a:tr>
              <a:tr h="362290">
                <a:tc>
                  <a:txBody>
                    <a:bodyPr/>
                    <a:lstStyle/>
                    <a:p>
                      <a:pPr marL="73660" algn="l">
                        <a:lnSpc>
                          <a:spcPts val="1020"/>
                        </a:lnSpc>
                        <a:spcBef>
                          <a:spcPts val="235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CRO350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235"/>
                        </a:spcBef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GCA_002245555.1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r>
                        <a:rPr lang="pt-PT" sz="1200" b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Bottlenose</a:t>
                      </a:r>
                      <a:r>
                        <a:rPr lang="pt-PT" sz="12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200" b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dolphin</a:t>
                      </a:r>
                      <a:r>
                        <a:rPr lang="pt-PT" sz="12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, </a:t>
                      </a:r>
                      <a:r>
                        <a:rPr lang="pt-PT" sz="1200" b="0" i="1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Tursiops</a:t>
                      </a:r>
                      <a:r>
                        <a:rPr lang="pt-PT" sz="1200" b="0" i="1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200" b="0" i="1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truncatus</a:t>
                      </a:r>
                      <a:endParaRPr lang="pt-PT" sz="1200" b="0" i="1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235"/>
                        </a:spcBef>
                      </a:pPr>
                      <a:r>
                        <a:rPr lang="pt-PT" sz="1100" b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Croatia</a:t>
                      </a:r>
                      <a:r>
                        <a:rPr lang="pt-PT" sz="11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, 2015 </a:t>
                      </a:r>
                      <a:r>
                        <a:rPr lang="pt-PT" sz="10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(</a:t>
                      </a:r>
                      <a:r>
                        <a:rPr lang="pt-PT" sz="1000" b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Duvnjak</a:t>
                      </a:r>
                      <a:r>
                        <a:rPr lang="pt-PT" sz="10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000" b="0" i="1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et</a:t>
                      </a:r>
                      <a:r>
                        <a:rPr lang="pt-PT" sz="1000" b="0" i="1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al</a:t>
                      </a:r>
                      <a:r>
                        <a:rPr lang="pt-PT" sz="10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. </a:t>
                      </a:r>
                      <a:r>
                        <a:rPr lang="pt-PT" sz="1000" b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Unpublished</a:t>
                      </a:r>
                      <a:r>
                        <a:rPr lang="pt-PT" sz="10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)</a:t>
                      </a: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3802433"/>
                  </a:ext>
                </a:extLst>
              </a:tr>
              <a:tr h="377386">
                <a:tc>
                  <a:txBody>
                    <a:bodyPr/>
                    <a:lstStyle/>
                    <a:p>
                      <a:pPr marL="73660" algn="l">
                        <a:lnSpc>
                          <a:spcPts val="1020"/>
                        </a:lnSpc>
                        <a:spcBef>
                          <a:spcPts val="21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BD1442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210"/>
                        </a:spcBef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GCA_014193785.1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r>
                        <a:rPr lang="pt-PT" sz="1200" b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Bottlenose</a:t>
                      </a:r>
                      <a:r>
                        <a:rPr lang="pt-PT" sz="12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200" b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dolphin</a:t>
                      </a:r>
                      <a:r>
                        <a:rPr lang="pt-PT" sz="12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, </a:t>
                      </a:r>
                      <a:r>
                        <a:rPr lang="pt-PT" sz="1200" b="0" i="1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Tursiops</a:t>
                      </a:r>
                      <a:r>
                        <a:rPr lang="pt-PT" sz="1200" b="0" i="1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200" b="0" i="1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truncatus</a:t>
                      </a:r>
                      <a:endParaRPr lang="pt-PT" sz="1200" b="0" i="1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210"/>
                        </a:spcBef>
                      </a:pPr>
                      <a:r>
                        <a:rPr lang="pt-PT" sz="1100" b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Japan</a:t>
                      </a:r>
                      <a:r>
                        <a:rPr lang="pt-PT" sz="11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, 2018 </a:t>
                      </a:r>
                      <a:r>
                        <a:rPr lang="pt-PT" sz="10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(</a:t>
                      </a:r>
                      <a:r>
                        <a:rPr lang="pt-PT" sz="1000" b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Ueno</a:t>
                      </a:r>
                      <a:r>
                        <a:rPr lang="pt-PT" sz="10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000" b="0" i="1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et</a:t>
                      </a:r>
                      <a:r>
                        <a:rPr lang="pt-PT" sz="1000" b="0" i="1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al</a:t>
                      </a:r>
                      <a:r>
                        <a:rPr lang="pt-PT" sz="10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. 2020. </a:t>
                      </a:r>
                      <a:r>
                        <a:rPr lang="pt-PT" sz="1000" b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https</a:t>
                      </a:r>
                      <a:r>
                        <a:rPr lang="pt-PT" sz="10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://</a:t>
                      </a:r>
                      <a:r>
                        <a:rPr lang="pt-PT" sz="1000" b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doi.org</a:t>
                      </a:r>
                      <a:r>
                        <a:rPr lang="pt-PT" sz="10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/10.1128/MRA.00925-20.)</a:t>
                      </a: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1598418"/>
                  </a:ext>
                </a:extLst>
              </a:tr>
              <a:tr h="358384">
                <a:tc>
                  <a:txBody>
                    <a:bodyPr/>
                    <a:lstStyle/>
                    <a:p>
                      <a:pPr marL="73660" algn="l">
                        <a:lnSpc>
                          <a:spcPts val="1020"/>
                        </a:lnSpc>
                        <a:spcBef>
                          <a:spcPts val="175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Cudo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GCA_000182425.1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r>
                        <a:rPr lang="pt-PT" sz="1200" b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Bottlenose</a:t>
                      </a:r>
                      <a:r>
                        <a:rPr lang="pt-PT" sz="12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200" b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dolphin</a:t>
                      </a:r>
                      <a:r>
                        <a:rPr lang="pt-PT" sz="12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, </a:t>
                      </a:r>
                      <a:r>
                        <a:rPr lang="pt-PT" sz="1200" b="0" i="1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Tursiops</a:t>
                      </a:r>
                      <a:r>
                        <a:rPr lang="pt-PT" sz="1200" b="0" i="1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200" b="0" i="1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truncatus</a:t>
                      </a:r>
                      <a:endParaRPr lang="pt-PT" sz="1200" b="0" i="1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r>
                        <a:rPr lang="pt-PT" sz="1100" b="0" kern="1200" dirty="0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France,</a:t>
                      </a:r>
                      <a:r>
                        <a:rPr lang="pt-PT" sz="11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2013 </a:t>
                      </a:r>
                      <a:r>
                        <a:rPr lang="pt-PT" sz="10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(</a:t>
                      </a:r>
                      <a:r>
                        <a:rPr lang="pt-PT" sz="1000" b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Setubal</a:t>
                      </a:r>
                      <a:r>
                        <a:rPr lang="pt-PT" sz="10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000" b="0" i="1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et</a:t>
                      </a:r>
                      <a:r>
                        <a:rPr lang="pt-PT" sz="1000" b="0" i="1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al</a:t>
                      </a:r>
                      <a:r>
                        <a:rPr lang="pt-PT" sz="10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. </a:t>
                      </a:r>
                      <a:r>
                        <a:rPr lang="pt-PT" sz="1000" b="0" kern="1200" dirty="0" err="1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Unpublished</a:t>
                      </a:r>
                      <a:r>
                        <a:rPr lang="pt-PT" sz="10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)</a:t>
                      </a: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4583628"/>
                  </a:ext>
                </a:extLst>
              </a:tr>
              <a:tr h="377386">
                <a:tc>
                  <a:txBody>
                    <a:bodyPr/>
                    <a:lstStyle/>
                    <a:p>
                      <a:pPr marL="73660" algn="l">
                        <a:lnSpc>
                          <a:spcPts val="1020"/>
                        </a:lnSpc>
                        <a:spcBef>
                          <a:spcPts val="235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M644/ 93/ 1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235"/>
                        </a:spcBef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GCA_000157835.1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20"/>
                        </a:lnSpc>
                        <a:spcBef>
                          <a:spcPts val="175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highlight>
                            <a:srgbClr val="FFFF00"/>
                          </a:highlight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Common dolphin</a:t>
                      </a:r>
                      <a:r>
                        <a:rPr kumimoji="0" lang="en-US" sz="12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highlight>
                            <a:srgbClr val="FFFF00"/>
                          </a:highlight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, D</a:t>
                      </a:r>
                      <a:r>
                        <a:rPr kumimoji="0" lang="pt-PT" sz="1200" b="0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highlight>
                            <a:srgbClr val="FFFF00"/>
                          </a:highlight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elphinus</a:t>
                      </a:r>
                      <a:r>
                        <a:rPr kumimoji="0" lang="pt-PT" sz="12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highlight>
                            <a:srgbClr val="FFFF00"/>
                          </a:highlight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kumimoji="0" lang="pt-PT" sz="1200" b="0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highlight>
                            <a:srgbClr val="FFFF00"/>
                          </a:highlight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delphis</a:t>
                      </a:r>
                      <a:r>
                        <a:rPr kumimoji="0" lang="pt-PT" sz="12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highlight>
                            <a:srgbClr val="FFFF00"/>
                          </a:highlight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235"/>
                        </a:spcBef>
                      </a:pPr>
                      <a:r>
                        <a:rPr lang="pt-PT" sz="1000" b="0" i="0" kern="1200" dirty="0" err="1">
                          <a:solidFill>
                            <a:schemeClr val="tx1"/>
                          </a:solidFill>
                          <a:effectLst/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Scotland</a:t>
                      </a:r>
                      <a:r>
                        <a:rPr lang="pt-PT" sz="1000" b="0" i="0" kern="1200" dirty="0">
                          <a:solidFill>
                            <a:schemeClr val="tx1"/>
                          </a:solidFill>
                          <a:effectLst/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(</a:t>
                      </a:r>
                      <a:r>
                        <a:rPr lang="pt-PT" sz="1000" b="0" i="0" kern="1200" dirty="0" err="1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Ward</a:t>
                      </a:r>
                      <a:r>
                        <a:rPr lang="pt-PT" sz="10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000" b="0" i="1" kern="1200" dirty="0" err="1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et</a:t>
                      </a:r>
                      <a:r>
                        <a:rPr lang="pt-PT" sz="1000" b="0" i="1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al</a:t>
                      </a:r>
                      <a:r>
                        <a:rPr lang="pt-PT" sz="10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. </a:t>
                      </a:r>
                      <a:r>
                        <a:rPr lang="pt-PT" sz="1000" b="0" i="0" kern="1200" dirty="0" err="1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Unpublished</a:t>
                      </a:r>
                      <a:r>
                        <a:rPr lang="pt-PT" sz="1000" b="0" i="0" kern="1200" dirty="0">
                          <a:solidFill>
                            <a:schemeClr val="tx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)</a:t>
                      </a:r>
                      <a:endParaRPr lang="pt-PT" sz="1000" b="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3464724"/>
                  </a:ext>
                </a:extLst>
              </a:tr>
              <a:tr h="362290">
                <a:tc>
                  <a:txBody>
                    <a:bodyPr/>
                    <a:lstStyle/>
                    <a:p>
                      <a:pPr marL="73660" algn="l">
                        <a:lnSpc>
                          <a:spcPts val="1020"/>
                        </a:lnSpc>
                        <a:spcBef>
                          <a:spcPts val="175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M13/ 05/ 1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GCA_000157855.1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lnSpc>
                          <a:spcPts val="1020"/>
                        </a:lnSpc>
                        <a:spcBef>
                          <a:spcPts val="175"/>
                        </a:spcBef>
                      </a:pPr>
                      <a:r>
                        <a:rPr lang="pt-PT" sz="1200" b="0" i="0" kern="1200" dirty="0" err="1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Striped</a:t>
                      </a:r>
                      <a:r>
                        <a:rPr lang="pt-PT" sz="1200" b="0" i="0" kern="1200" dirty="0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200" b="0" i="0" kern="1200" dirty="0" err="1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dolphin</a:t>
                      </a:r>
                      <a:r>
                        <a:rPr lang="pt-PT" sz="1200" b="0" i="0" kern="1200" dirty="0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, </a:t>
                      </a:r>
                      <a:r>
                        <a:rPr lang="pt-PT" sz="1200" b="0" i="1" kern="1200" dirty="0" err="1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Stenella</a:t>
                      </a:r>
                      <a:r>
                        <a:rPr lang="pt-PT" sz="1200" b="0" i="1" kern="1200" dirty="0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lang="pt-PT" sz="1200" b="0" i="1" kern="1200" dirty="0" err="1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coeruleoalba</a:t>
                      </a:r>
                      <a:endParaRPr lang="pt-PT" sz="1200" b="0" i="1" kern="1200" dirty="0">
                        <a:solidFill>
                          <a:schemeClr val="tx1"/>
                        </a:solidFill>
                        <a:highlight>
                          <a:srgbClr val="FFFF00"/>
                        </a:highlight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20"/>
                        </a:lnSpc>
                        <a:spcBef>
                          <a:spcPts val="235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pt-PT" sz="10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highlight>
                            <a:srgbClr val="FFFF00"/>
                          </a:highlight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Scotland</a:t>
                      </a:r>
                      <a:r>
                        <a:rPr kumimoji="0" lang="pt-PT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(</a:t>
                      </a:r>
                      <a:r>
                        <a:rPr kumimoji="0" lang="pt-PT" sz="10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Ward</a:t>
                      </a:r>
                      <a:r>
                        <a:rPr kumimoji="0" lang="pt-PT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kumimoji="0" lang="pt-PT" sz="1000" b="0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et</a:t>
                      </a:r>
                      <a:r>
                        <a:rPr kumimoji="0" lang="pt-PT" sz="10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al</a:t>
                      </a:r>
                      <a:r>
                        <a:rPr kumimoji="0" lang="pt-PT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. </a:t>
                      </a:r>
                      <a:r>
                        <a:rPr kumimoji="0" lang="pt-PT" sz="10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Unpublished</a:t>
                      </a:r>
                      <a:r>
                        <a:rPr kumimoji="0" lang="pt-PT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)</a:t>
                      </a: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7975037"/>
                  </a:ext>
                </a:extLst>
              </a:tr>
              <a:tr h="363548">
                <a:tc>
                  <a:txBody>
                    <a:bodyPr/>
                    <a:lstStyle/>
                    <a:p>
                      <a:pPr marL="73660" algn="l">
                        <a:lnSpc>
                          <a:spcPts val="1020"/>
                        </a:lnSpc>
                        <a:spcBef>
                          <a:spcPts val="235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M490/ 95/ 1</a:t>
                      </a:r>
                      <a:endParaRPr lang="pt-PT" sz="120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20"/>
                        </a:lnSpc>
                        <a:spcBef>
                          <a:spcPts val="235"/>
                        </a:spcBef>
                      </a:pPr>
                      <a:r>
                        <a:rPr lang="en-US" sz="1200" b="0" kern="1200" dirty="0">
                          <a:solidFill>
                            <a:schemeClr val="tx1"/>
                          </a:solidFill>
                          <a:latin typeface="Palatino" pitchFamily="2" charset="77"/>
                          <a:ea typeface="Palatino" pitchFamily="2" charset="77"/>
                        </a:rPr>
                        <a:t>GCA_000158755.1</a:t>
                      </a:r>
                      <a:endParaRPr lang="pt-PT" sz="1200" b="0" kern="1200" dirty="0">
                        <a:solidFill>
                          <a:schemeClr val="tx1"/>
                        </a:solidFill>
                        <a:latin typeface="Palatino" pitchFamily="2" charset="77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20"/>
                        </a:lnSpc>
                        <a:spcBef>
                          <a:spcPts val="175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pt-PT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highlight>
                            <a:srgbClr val="FFFF00"/>
                          </a:highlight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Common</a:t>
                      </a:r>
                      <a:r>
                        <a:rPr kumimoji="0" lang="pt-PT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highlight>
                            <a:srgbClr val="FFFF00"/>
                          </a:highlight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kumimoji="0" lang="pt-PT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highlight>
                            <a:srgbClr val="FFFF00"/>
                          </a:highlight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seal</a:t>
                      </a:r>
                      <a:r>
                        <a:rPr kumimoji="0" lang="pt-PT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highlight>
                            <a:srgbClr val="FFFF00"/>
                          </a:highlight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, </a:t>
                      </a:r>
                      <a:r>
                        <a:rPr lang="pt-PT" sz="1200" b="0" i="1" dirty="0" err="1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/>
                        </a:rPr>
                        <a:t>Phoca</a:t>
                      </a:r>
                      <a:r>
                        <a:rPr lang="pt-PT" sz="1200" b="0" i="1" dirty="0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/>
                        </a:rPr>
                        <a:t> </a:t>
                      </a:r>
                      <a:r>
                        <a:rPr lang="pt-PT" sz="1200" b="0" i="1" dirty="0" err="1">
                          <a:solidFill>
                            <a:schemeClr val="tx1"/>
                          </a:solidFill>
                          <a:highlight>
                            <a:srgbClr val="FFFF00"/>
                          </a:highlight>
                          <a:latin typeface="Palatino"/>
                        </a:rPr>
                        <a:t>vitulina</a:t>
                      </a:r>
                      <a:endParaRPr kumimoji="0" lang="pt-PT" sz="1200" b="0" i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highlight>
                          <a:srgbClr val="FFFF00"/>
                        </a:highlight>
                        <a:uLnTx/>
                        <a:uFillTx/>
                        <a:latin typeface="Palatino"/>
                        <a:ea typeface="Palatino" pitchFamily="2" charset="77"/>
                        <a:cs typeface="+mn-cs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ts val="1020"/>
                        </a:lnSpc>
                        <a:spcBef>
                          <a:spcPts val="235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pt-PT" sz="10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highlight>
                            <a:srgbClr val="FFFF00"/>
                          </a:highlight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Scotland</a:t>
                      </a:r>
                      <a:r>
                        <a:rPr kumimoji="0" lang="pt-PT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highlight>
                            <a:srgbClr val="FFFF00"/>
                          </a:highlight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kumimoji="0" lang="pt-PT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(</a:t>
                      </a:r>
                      <a:r>
                        <a:rPr kumimoji="0" lang="pt-PT" sz="10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Ward</a:t>
                      </a:r>
                      <a:r>
                        <a:rPr kumimoji="0" lang="pt-PT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</a:t>
                      </a:r>
                      <a:r>
                        <a:rPr kumimoji="0" lang="pt-PT" sz="1000" b="0" i="1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et</a:t>
                      </a:r>
                      <a:r>
                        <a:rPr kumimoji="0" lang="pt-PT" sz="10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 al</a:t>
                      </a:r>
                      <a:r>
                        <a:rPr kumimoji="0" lang="pt-PT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. </a:t>
                      </a:r>
                      <a:r>
                        <a:rPr kumimoji="0" lang="pt-PT" sz="10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Unpublished</a:t>
                      </a:r>
                      <a:r>
                        <a:rPr kumimoji="0" lang="pt-PT" sz="10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Palatino" pitchFamily="2" charset="77"/>
                          <a:ea typeface="Palatino" pitchFamily="2" charset="77"/>
                          <a:cs typeface="+mn-cs"/>
                        </a:rPr>
                        <a:t>)</a:t>
                      </a: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17027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5609979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8</TotalTime>
  <Words>299</Words>
  <Application>Microsoft Macintosh PowerPoint</Application>
  <PresentationFormat>Ecrã Panorâmico</PresentationFormat>
  <Paragraphs>46</Paragraphs>
  <Slides>1</Slides>
  <Notes>1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rosoft Office User</dc:creator>
  <cp:lastModifiedBy>Microsoft Office User</cp:lastModifiedBy>
  <cp:revision>15</cp:revision>
  <dcterms:created xsi:type="dcterms:W3CDTF">2024-10-27T12:40:04Z</dcterms:created>
  <dcterms:modified xsi:type="dcterms:W3CDTF">2025-01-16T23:54:40Z</dcterms:modified>
</cp:coreProperties>
</file>